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8"/>
  </p:notesMasterIdLst>
  <p:sldIdLst>
    <p:sldId id="256" r:id="rId5"/>
    <p:sldId id="2147475145" r:id="rId6"/>
    <p:sldId id="214747514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F0B3CF-B7AD-4DA3-BB3B-9EB0BA9CFBD2}" v="5" dt="2023-03-02T15:30:06.730"/>
    <p1510:client id="{3D85446F-A5BE-4DD2-AED5-1F100425BEA5}" v="30" dt="2023-03-02T15:09:36.11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6357" autoAdjust="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ppdcentral-my.sharepoint.com/personal/sariya_udayachalerm_evidera_com/Documents/Projects/EVA-23556%20Selexipag/Figures%20for%20M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ppdcentral-my.sharepoint.com/personal/sariya_udayachalerm_evidera_com/Documents/Projects/EVA-23556%20Selexipag/Figures%20for%20M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ppdcentral-my.sharepoint.com/personal/sariya_udayachalerm_evidera_com/Documents/Projects/EVA-23556%20Selexipag/Figures%20for%20M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ppdcentral-my.sharepoint.com/personal/sariya_udayachalerm_evidera_com/Documents/Projects/EVA-23556%20Selexipag/Figures%20for%20M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'Figure 7a and S2a'!$L$3</c:f>
              <c:strCache>
                <c:ptCount val="1"/>
                <c:pt idx="0">
                  <c:v>SEL ≤12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A76-4364-8CDB-588B7A9A4A0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A76-4364-8CDB-588B7A9A4A0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A76-4364-8CDB-588B7A9A4A04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A76-4364-8CDB-588B7A9A4A04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AA76-4364-8CDB-588B7A9A4A04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Figure 7a and S2a'!$K$4:$K$8</c:f>
              <c:strCache>
                <c:ptCount val="5"/>
                <c:pt idx="0">
                  <c:v>Hospitalizations</c:v>
                </c:pt>
                <c:pt idx="1">
                  <c:v>Physician Office</c:v>
                </c:pt>
                <c:pt idx="2">
                  <c:v>ED</c:v>
                </c:pt>
                <c:pt idx="3">
                  <c:v>Other Outpatient</c:v>
                </c:pt>
                <c:pt idx="4">
                  <c:v>Other Costs</c:v>
                </c:pt>
              </c:strCache>
            </c:strRef>
          </c:cat>
          <c:val>
            <c:numRef>
              <c:f>'Figure 7a and S2a'!$L$4:$L$8</c:f>
              <c:numCache>
                <c:formatCode>0</c:formatCode>
                <c:ptCount val="5"/>
                <c:pt idx="0">
                  <c:v>11395.58</c:v>
                </c:pt>
                <c:pt idx="1">
                  <c:v>2155.92</c:v>
                </c:pt>
                <c:pt idx="2">
                  <c:v>1117.03</c:v>
                </c:pt>
                <c:pt idx="3">
                  <c:v>11213.84</c:v>
                </c:pt>
                <c:pt idx="4">
                  <c:v>448.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AA76-4364-8CDB-588B7A9A4A0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'Figure 7a and S2a'!$N$3</c:f>
              <c:strCache>
                <c:ptCount val="1"/>
                <c:pt idx="0">
                  <c:v>No PPA ≤12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3CA-4F5C-A7BD-B081B7AE1A8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3CA-4F5C-A7BD-B081B7AE1A8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3CA-4F5C-A7BD-B081B7AE1A8E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3CA-4F5C-A7BD-B081B7AE1A8E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3CA-4F5C-A7BD-B081B7AE1A8E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Figure 7a and S2a'!$M$4:$M$8</c:f>
              <c:strCache>
                <c:ptCount val="5"/>
                <c:pt idx="0">
                  <c:v>Hospitalizations</c:v>
                </c:pt>
                <c:pt idx="1">
                  <c:v>Physician Office</c:v>
                </c:pt>
                <c:pt idx="2">
                  <c:v>ED</c:v>
                </c:pt>
                <c:pt idx="3">
                  <c:v>Other Outpatient</c:v>
                </c:pt>
                <c:pt idx="4">
                  <c:v>Other Costs</c:v>
                </c:pt>
              </c:strCache>
            </c:strRef>
          </c:cat>
          <c:val>
            <c:numRef>
              <c:f>'Figure 7a and S2a'!$N$4:$N$8</c:f>
              <c:numCache>
                <c:formatCode>0</c:formatCode>
                <c:ptCount val="5"/>
                <c:pt idx="0">
                  <c:v>25866.33</c:v>
                </c:pt>
                <c:pt idx="1">
                  <c:v>3341.16</c:v>
                </c:pt>
                <c:pt idx="2">
                  <c:v>1656.77</c:v>
                </c:pt>
                <c:pt idx="3">
                  <c:v>16957.12</c:v>
                </c:pt>
                <c:pt idx="4">
                  <c:v>533.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43CA-4F5C-A7BD-B081B7AE1A8E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'Figure 7b and S2b'!$L$4</c:f>
              <c:strCache>
                <c:ptCount val="1"/>
                <c:pt idx="0">
                  <c:v>SEL ≤12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BE3-46C7-8B18-34B4AD714B96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BE3-46C7-8B18-34B4AD714B96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BE3-46C7-8B18-34B4AD714B96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BE3-46C7-8B18-34B4AD714B96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6BE3-46C7-8B18-34B4AD714B96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Figure 7b and S2b'!$K$5:$K$9</c:f>
              <c:strCache>
                <c:ptCount val="5"/>
                <c:pt idx="0">
                  <c:v>Hospitalizations</c:v>
                </c:pt>
                <c:pt idx="1">
                  <c:v>Physician Office</c:v>
                </c:pt>
                <c:pt idx="2">
                  <c:v>ED</c:v>
                </c:pt>
                <c:pt idx="3">
                  <c:v>Other Outpatient</c:v>
                </c:pt>
                <c:pt idx="4">
                  <c:v>Other Costs</c:v>
                </c:pt>
              </c:strCache>
            </c:strRef>
          </c:cat>
          <c:val>
            <c:numRef>
              <c:f>'Figure 7b and S2b'!$L$5:$L$9</c:f>
              <c:numCache>
                <c:formatCode>0</c:formatCode>
                <c:ptCount val="5"/>
                <c:pt idx="0">
                  <c:v>9315.67</c:v>
                </c:pt>
                <c:pt idx="1">
                  <c:v>395.44</c:v>
                </c:pt>
                <c:pt idx="2">
                  <c:v>694.82</c:v>
                </c:pt>
                <c:pt idx="3">
                  <c:v>2907.97</c:v>
                </c:pt>
                <c:pt idx="4">
                  <c:v>448.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6BE3-46C7-8B18-34B4AD714B96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'Figure 7b and S2b'!$N$4</c:f>
              <c:strCache>
                <c:ptCount val="1"/>
                <c:pt idx="0">
                  <c:v>No PPA ≤12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4F9-4870-A9EE-6D264147C8A1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4F9-4870-A9EE-6D264147C8A1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4F9-4870-A9EE-6D264147C8A1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4F9-4870-A9EE-6D264147C8A1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34F9-4870-A9EE-6D264147C8A1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Figure 7b and S2b'!$M$5:$M$9</c:f>
              <c:strCache>
                <c:ptCount val="5"/>
                <c:pt idx="0">
                  <c:v>Hospitalizations</c:v>
                </c:pt>
                <c:pt idx="1">
                  <c:v>Physician Office</c:v>
                </c:pt>
                <c:pt idx="2">
                  <c:v>ED</c:v>
                </c:pt>
                <c:pt idx="3">
                  <c:v>Other Outpatient</c:v>
                </c:pt>
                <c:pt idx="4">
                  <c:v>Other Costs</c:v>
                </c:pt>
              </c:strCache>
            </c:strRef>
          </c:cat>
          <c:val>
            <c:numRef>
              <c:f>'Figure 7b and S2b'!$N$5:$N$9</c:f>
              <c:numCache>
                <c:formatCode>0</c:formatCode>
                <c:ptCount val="5"/>
                <c:pt idx="0">
                  <c:v>16935.89</c:v>
                </c:pt>
                <c:pt idx="1">
                  <c:v>526.22</c:v>
                </c:pt>
                <c:pt idx="2">
                  <c:v>398.01</c:v>
                </c:pt>
                <c:pt idx="3">
                  <c:v>3935.92</c:v>
                </c:pt>
                <c:pt idx="4">
                  <c:v>324.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34F9-4870-A9EE-6D264147C8A1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EE3E59-A730-4C58-B9AF-D5E7BD703E50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143623-B9EA-4978-A18E-5204618EA0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187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C4334A-C787-425C-AAD0-9D067851162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3777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2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143623-B9EA-4978-A18E-5204618EA01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94125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2b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143623-B9EA-4978-A18E-5204618EA01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9725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9F9D14-C0E0-E140-79AF-9481A8F91E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921DE9F-CD2E-1F52-3501-E4CEC9928F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8748EF-E363-C282-B061-D084E56A3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FAF3C-A77B-438F-BB27-171BCF826698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10C5CB-E30B-CF48-D455-4F6BDC9B9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0019F3-6293-2519-C016-8EC7B34A3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6B2A9-16FB-4985-A6E6-8B22A8FD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838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2796E9-7CA0-A4F5-1E1A-0CBC17F433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7DC32E-485C-3B70-1961-17F754A2F1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9B6F29-4F73-F8C8-0D77-9AA446B00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FAF3C-A77B-438F-BB27-171BCF826698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7D97DD-3378-060F-2BB1-FE03C68BC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99AEA2-DCC0-EE9C-03CF-5205DB97A1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6B2A9-16FB-4985-A6E6-8B22A8FD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98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29B43E9-C38A-3180-D049-F1285AFA21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B5A181-AEC7-735D-A0D2-BA24ABCF1B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7F826E-19ED-B046-EE2C-6DEA895EB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FAF3C-A77B-438F-BB27-171BCF826698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850E34-72AE-668D-1168-D9504A934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EBAAEC-BDEF-9143-AF35-2DFE7D480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6B2A9-16FB-4985-A6E6-8B22A8FD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975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758AEB-0C48-B1A6-340D-5BB0CBC040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E6EE2D-03DE-99F6-EAB1-74044CBF7E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F80591-7018-4CCD-3647-C1A098739A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FAF3C-A77B-438F-BB27-171BCF826698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2DE6AE-65F0-534E-702E-946E56AF8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509B28-01F4-B5BD-4E61-594C46BBDF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6B2A9-16FB-4985-A6E6-8B22A8FD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62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922919-2BFE-9EC7-286D-2D11E0195C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17DB19-B645-87EA-E0F9-E4A9A9283E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CCEFD3-B18F-DCB2-0A51-741124302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FAF3C-A77B-438F-BB27-171BCF826698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1A162D-C186-DBD7-28FB-E56B3DC52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F73C42-44B7-E19C-46CA-DADD10ACE6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6B2A9-16FB-4985-A6E6-8B22A8FD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800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D7E16D-06E5-45A8-1014-425AE9F887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FF7BAD-3921-8035-EFF8-20A216F86B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8E23B9-42DA-FA2A-10DB-A33553CC48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6919DF-6C0F-A6F2-8595-E8E8D330B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FAF3C-A77B-438F-BB27-171BCF826698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2CEBCF-4DC0-10D0-A1E5-5692455B49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C659A6-C0A6-4EA8-F499-BD7311596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6B2A9-16FB-4985-A6E6-8B22A8FD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8497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C2B074-9346-B53E-C5BF-853AB2558B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906E2F-232A-69E7-609F-78EA1EF924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8C45FA-A7E7-527B-E8AF-2BD01601D3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DF27AB4-4AF9-0769-95FA-7CAA6A8C68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7351B8-B6D3-8B13-DB99-26EA3189F85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E3B4EB1-7017-8FD4-12EA-F94B6DF72C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FAF3C-A77B-438F-BB27-171BCF826698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D06EDB-7417-E02D-44C9-C2A18D89D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FD2871-8CC0-E0D6-CEA1-EC355958F6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6B2A9-16FB-4985-A6E6-8B22A8FD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53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B245B1-FE48-B855-4D6C-33F313F4C4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0FCBB89-454A-3C85-2CDD-36B567F6E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FAF3C-A77B-438F-BB27-171BCF826698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A54DCE2-360F-31F4-BFC5-84604E0F3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2F92732-B85D-3B38-066E-A307A7CC51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6B2A9-16FB-4985-A6E6-8B22A8FD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354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39A4E53-3FF4-7AAB-7F9C-55007B941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FAF3C-A77B-438F-BB27-171BCF826698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A20E525-D978-9AEE-0B93-83D4761F20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B05B40-FB5C-A750-EE80-4F054A24FA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6B2A9-16FB-4985-A6E6-8B22A8FD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354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0EF434-344E-A747-C650-43E431297A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695EEB-988D-6EFE-1F1D-AD99A856E7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533F60-EB9B-F609-24BF-D476995C64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F24F50-413C-468E-2462-F13C80C4DF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FAF3C-A77B-438F-BB27-171BCF826698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158F37-4DB3-6C83-7AA8-53ECAD0D37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3506EC-969F-21A9-9226-30BCCDB6CE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6B2A9-16FB-4985-A6E6-8B22A8FD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359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58D6B3-BA8F-DFC7-E794-C1D4845585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AD815D-901F-322F-1729-CB319F61ED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45D924-5881-18A3-EC17-F1A317F030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2F6A39-783E-7DE5-2375-8E0C6289C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FAF3C-A77B-438F-BB27-171BCF826698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55150F-A10E-A521-C280-7FAF45FDA8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FE1CEF-BAC1-BA1F-6852-9E8C5F744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6B2A9-16FB-4985-A6E6-8B22A8FD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682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76497BA-EEFF-2387-AFAD-4D73AE5A14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C39223-5025-9058-BFE4-F92E568EA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CAA71C-4300-DE97-2CD6-41261FFFB2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4FAF3C-A77B-438F-BB27-171BCF826698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4FD99F-A5FA-8478-C98E-ED54A1B1EB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66F45D-704A-3771-0D43-F99DCD2459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56B2A9-16FB-4985-A6E6-8B22A8FD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085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Left Brace 3">
            <a:extLst>
              <a:ext uri="{FF2B5EF4-FFF2-40B4-BE49-F238E27FC236}">
                <a16:creationId xmlns:a16="http://schemas.microsoft.com/office/drawing/2014/main" id="{03D571BB-FA2B-42E8-9C4E-0CB27AC9BC56}"/>
              </a:ext>
            </a:extLst>
          </p:cNvPr>
          <p:cNvSpPr/>
          <p:nvPr/>
        </p:nvSpPr>
        <p:spPr>
          <a:xfrm rot="5400000">
            <a:off x="2310498" y="674101"/>
            <a:ext cx="155448" cy="9144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Left Brace 4">
            <a:extLst>
              <a:ext uri="{FF2B5EF4-FFF2-40B4-BE49-F238E27FC236}">
                <a16:creationId xmlns:a16="http://schemas.microsoft.com/office/drawing/2014/main" id="{309A3555-527C-43B4-8811-93D3E9053211}"/>
              </a:ext>
            </a:extLst>
          </p:cNvPr>
          <p:cNvSpPr/>
          <p:nvPr/>
        </p:nvSpPr>
        <p:spPr>
          <a:xfrm rot="5400000">
            <a:off x="5789658" y="-1875024"/>
            <a:ext cx="154800" cy="60120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Left Brace 5">
            <a:extLst>
              <a:ext uri="{FF2B5EF4-FFF2-40B4-BE49-F238E27FC236}">
                <a16:creationId xmlns:a16="http://schemas.microsoft.com/office/drawing/2014/main" id="{6B8FFE20-ABBC-449E-BC5B-8DE0476E0989}"/>
              </a:ext>
            </a:extLst>
          </p:cNvPr>
          <p:cNvSpPr/>
          <p:nvPr/>
        </p:nvSpPr>
        <p:spPr>
          <a:xfrm rot="5400000">
            <a:off x="8096783" y="-412798"/>
            <a:ext cx="155448" cy="41760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Left Brace 6">
            <a:extLst>
              <a:ext uri="{FF2B5EF4-FFF2-40B4-BE49-F238E27FC236}">
                <a16:creationId xmlns:a16="http://schemas.microsoft.com/office/drawing/2014/main" id="{17718FE1-A475-46F2-BBC5-6C973B5B2D36}"/>
              </a:ext>
            </a:extLst>
          </p:cNvPr>
          <p:cNvSpPr/>
          <p:nvPr/>
        </p:nvSpPr>
        <p:spPr>
          <a:xfrm rot="5400000">
            <a:off x="3922818" y="-412798"/>
            <a:ext cx="155448" cy="41760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9444A185-CC35-4C24-94F7-AFCB9F0C22A4}"/>
              </a:ext>
            </a:extLst>
          </p:cNvPr>
          <p:cNvCxnSpPr>
            <a:cxnSpLocks/>
          </p:cNvCxnSpPr>
          <p:nvPr/>
        </p:nvCxnSpPr>
        <p:spPr>
          <a:xfrm>
            <a:off x="1924050" y="2457463"/>
            <a:ext cx="83439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55DB6301-00B6-4EC4-A085-332C08C21DD8}"/>
              </a:ext>
            </a:extLst>
          </p:cNvPr>
          <p:cNvCxnSpPr>
            <a:cxnSpLocks/>
          </p:cNvCxnSpPr>
          <p:nvPr/>
        </p:nvCxnSpPr>
        <p:spPr>
          <a:xfrm>
            <a:off x="1924050" y="4577443"/>
            <a:ext cx="83439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129F7EC8-124E-4B9A-ABA8-E2CABC7C8352}"/>
              </a:ext>
            </a:extLst>
          </p:cNvPr>
          <p:cNvCxnSpPr>
            <a:cxnSpLocks/>
          </p:cNvCxnSpPr>
          <p:nvPr/>
        </p:nvCxnSpPr>
        <p:spPr>
          <a:xfrm>
            <a:off x="1924050" y="2245191"/>
            <a:ext cx="0" cy="43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E5F237A-14BA-462B-9C14-E4CE906B5942}"/>
              </a:ext>
            </a:extLst>
          </p:cNvPr>
          <p:cNvCxnSpPr>
            <a:cxnSpLocks/>
          </p:cNvCxnSpPr>
          <p:nvPr/>
        </p:nvCxnSpPr>
        <p:spPr>
          <a:xfrm>
            <a:off x="10273392" y="2250634"/>
            <a:ext cx="0" cy="43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E2DDF0D-94B4-4638-A087-9BBD0AEECDB3}"/>
              </a:ext>
            </a:extLst>
          </p:cNvPr>
          <p:cNvCxnSpPr>
            <a:cxnSpLocks/>
          </p:cNvCxnSpPr>
          <p:nvPr/>
        </p:nvCxnSpPr>
        <p:spPr>
          <a:xfrm>
            <a:off x="1924050" y="4346121"/>
            <a:ext cx="0" cy="43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1D3105E3-E519-4980-9EDE-360349833A98}"/>
              </a:ext>
            </a:extLst>
          </p:cNvPr>
          <p:cNvCxnSpPr>
            <a:cxnSpLocks/>
          </p:cNvCxnSpPr>
          <p:nvPr/>
        </p:nvCxnSpPr>
        <p:spPr>
          <a:xfrm>
            <a:off x="10273392" y="4370613"/>
            <a:ext cx="0" cy="43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EC60428A-73A6-4B14-859F-C528D6AD96F3}"/>
              </a:ext>
            </a:extLst>
          </p:cNvPr>
          <p:cNvSpPr txBox="1"/>
          <p:nvPr/>
        </p:nvSpPr>
        <p:spPr>
          <a:xfrm>
            <a:off x="9723666" y="2743215"/>
            <a:ext cx="1094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30 Sep 202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BC5856-884A-4D11-BFC9-AE5646D8C60E}"/>
              </a:ext>
            </a:extLst>
          </p:cNvPr>
          <p:cNvSpPr txBox="1"/>
          <p:nvPr/>
        </p:nvSpPr>
        <p:spPr>
          <a:xfrm>
            <a:off x="1384018" y="2707838"/>
            <a:ext cx="1094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01 Apr 201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D03D64-4C17-49E8-8F29-573BC763D559}"/>
              </a:ext>
            </a:extLst>
          </p:cNvPr>
          <p:cNvSpPr txBox="1"/>
          <p:nvPr/>
        </p:nvSpPr>
        <p:spPr>
          <a:xfrm>
            <a:off x="9729108" y="4830543"/>
            <a:ext cx="1094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30 Sep 202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2DDF358-F439-4D4D-B9EF-7E1405FB59AD}"/>
              </a:ext>
            </a:extLst>
          </p:cNvPr>
          <p:cNvSpPr txBox="1"/>
          <p:nvPr/>
        </p:nvSpPr>
        <p:spPr>
          <a:xfrm>
            <a:off x="1364968" y="4844150"/>
            <a:ext cx="1094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01 Apr 2015</a:t>
            </a:r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B1831256-BC49-4614-AECA-DF9F5EA95451}"/>
              </a:ext>
            </a:extLst>
          </p:cNvPr>
          <p:cNvSpPr/>
          <p:nvPr/>
        </p:nvSpPr>
        <p:spPr>
          <a:xfrm>
            <a:off x="3106675" y="2375820"/>
            <a:ext cx="180000" cy="1800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BD49DF77-9055-418B-A822-AED0417AB40F}"/>
              </a:ext>
            </a:extLst>
          </p:cNvPr>
          <p:cNvSpPr/>
          <p:nvPr/>
        </p:nvSpPr>
        <p:spPr>
          <a:xfrm>
            <a:off x="3106675" y="4488449"/>
            <a:ext cx="180000" cy="1800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4BDF280-7C69-4CB7-8B80-C68460AF62F6}"/>
              </a:ext>
            </a:extLst>
          </p:cNvPr>
          <p:cNvSpPr txBox="1"/>
          <p:nvPr/>
        </p:nvSpPr>
        <p:spPr>
          <a:xfrm>
            <a:off x="1404274" y="754133"/>
            <a:ext cx="19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6-Month Washout Period‡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FA9D2FF-CE70-4657-BF21-35B39E4F505C}"/>
              </a:ext>
            </a:extLst>
          </p:cNvPr>
          <p:cNvSpPr txBox="1"/>
          <p:nvPr/>
        </p:nvSpPr>
        <p:spPr>
          <a:xfrm>
            <a:off x="4522975" y="569467"/>
            <a:ext cx="26881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atient Identification Period</a:t>
            </a:r>
          </a:p>
          <a:p>
            <a:pPr algn="ctr"/>
            <a:r>
              <a:rPr lang="en-GB" sz="1200" dirty="0"/>
              <a:t>01 October 2015 – 30 September 2019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B7248C6-409C-439F-B485-4500F7A357BF}"/>
              </a:ext>
            </a:extLst>
          </p:cNvPr>
          <p:cNvSpPr txBox="1"/>
          <p:nvPr/>
        </p:nvSpPr>
        <p:spPr>
          <a:xfrm>
            <a:off x="3010542" y="1308137"/>
            <a:ext cx="19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re-Treatment Perio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0321C9D-EA72-4236-827C-84C63258BF13}"/>
              </a:ext>
            </a:extLst>
          </p:cNvPr>
          <p:cNvSpPr txBox="1"/>
          <p:nvPr/>
        </p:nvSpPr>
        <p:spPr>
          <a:xfrm>
            <a:off x="7184507" y="1308137"/>
            <a:ext cx="19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Follow-Up Perio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F9957B6-C483-4DEC-8DB1-B56D9309DAF4}"/>
              </a:ext>
            </a:extLst>
          </p:cNvPr>
          <p:cNvSpPr txBox="1"/>
          <p:nvPr/>
        </p:nvSpPr>
        <p:spPr>
          <a:xfrm>
            <a:off x="5106000" y="2116770"/>
            <a:ext cx="19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Index date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1A787785-17A3-4B99-899C-088A72B9EC9C}"/>
              </a:ext>
            </a:extLst>
          </p:cNvPr>
          <p:cNvCxnSpPr>
            <a:cxnSpLocks/>
          </p:cNvCxnSpPr>
          <p:nvPr/>
        </p:nvCxnSpPr>
        <p:spPr>
          <a:xfrm flipH="1">
            <a:off x="6086507" y="2476513"/>
            <a:ext cx="0" cy="21101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84050307-BE13-47E8-9F8B-4F0E1F215342}"/>
              </a:ext>
            </a:extLst>
          </p:cNvPr>
          <p:cNvSpPr txBox="1"/>
          <p:nvPr/>
        </p:nvSpPr>
        <p:spPr>
          <a:xfrm>
            <a:off x="5106000" y="3386464"/>
            <a:ext cx="19800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12-month landmark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5DC8C17-954C-4E91-9A9D-9BA5FFD18257}"/>
              </a:ext>
            </a:extLst>
          </p:cNvPr>
          <p:cNvSpPr txBox="1"/>
          <p:nvPr/>
        </p:nvSpPr>
        <p:spPr>
          <a:xfrm>
            <a:off x="9074507" y="3282952"/>
            <a:ext cx="237600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Earliest of death, disenrollment from the study database, diagnosis of CTEPH, or end of study period</a:t>
            </a:r>
          </a:p>
        </p:txBody>
      </p:sp>
      <p:sp>
        <p:nvSpPr>
          <p:cNvPr id="36" name="Star: 5 Points 35">
            <a:extLst>
              <a:ext uri="{FF2B5EF4-FFF2-40B4-BE49-F238E27FC236}">
                <a16:creationId xmlns:a16="http://schemas.microsoft.com/office/drawing/2014/main" id="{03D85DFA-175B-4B88-837B-8BF17D209FCE}"/>
              </a:ext>
            </a:extLst>
          </p:cNvPr>
          <p:cNvSpPr/>
          <p:nvPr/>
        </p:nvSpPr>
        <p:spPr>
          <a:xfrm>
            <a:off x="4392393" y="2356481"/>
            <a:ext cx="180000" cy="180000"/>
          </a:xfrm>
          <a:prstGeom prst="star5">
            <a:avLst/>
          </a:prstGeom>
          <a:solidFill>
            <a:schemeClr val="accent4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Star: 5 Points 36">
            <a:extLst>
              <a:ext uri="{FF2B5EF4-FFF2-40B4-BE49-F238E27FC236}">
                <a16:creationId xmlns:a16="http://schemas.microsoft.com/office/drawing/2014/main" id="{7B5C7F25-FE09-4773-A884-0D3AA260E483}"/>
              </a:ext>
            </a:extLst>
          </p:cNvPr>
          <p:cNvSpPr/>
          <p:nvPr/>
        </p:nvSpPr>
        <p:spPr>
          <a:xfrm>
            <a:off x="4414166" y="4492805"/>
            <a:ext cx="180000" cy="180000"/>
          </a:xfrm>
          <a:prstGeom prst="star5">
            <a:avLst/>
          </a:prstGeom>
          <a:solidFill>
            <a:schemeClr val="accent4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109D228-3D1E-4DB8-97D9-0476712A34FA}"/>
              </a:ext>
            </a:extLst>
          </p:cNvPr>
          <p:cNvSpPr txBox="1"/>
          <p:nvPr/>
        </p:nvSpPr>
        <p:spPr>
          <a:xfrm>
            <a:off x="2754393" y="2113110"/>
            <a:ext cx="3456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First prescription claim for selexipag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7E17B0B-382C-46F6-B308-4817D545D125}"/>
              </a:ext>
            </a:extLst>
          </p:cNvPr>
          <p:cNvSpPr txBox="1"/>
          <p:nvPr/>
        </p:nvSpPr>
        <p:spPr>
          <a:xfrm>
            <a:off x="3299063" y="4639717"/>
            <a:ext cx="2412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First prescription claim for PAH-specific treatment other than oral/inhaled PPAs (including selexipag)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FAC7576A-F6A6-4356-B300-04F2A74821B8}"/>
              </a:ext>
            </a:extLst>
          </p:cNvPr>
          <p:cNvCxnSpPr>
            <a:cxnSpLocks/>
            <a:stCxn id="20" idx="4"/>
            <a:endCxn id="21" idx="0"/>
          </p:cNvCxnSpPr>
          <p:nvPr/>
        </p:nvCxnSpPr>
        <p:spPr>
          <a:xfrm>
            <a:off x="3196675" y="2555820"/>
            <a:ext cx="0" cy="19326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53FE39F8-1682-461E-9342-18D40C93F01A}"/>
              </a:ext>
            </a:extLst>
          </p:cNvPr>
          <p:cNvSpPr txBox="1"/>
          <p:nvPr/>
        </p:nvSpPr>
        <p:spPr>
          <a:xfrm>
            <a:off x="2206675" y="3386464"/>
            <a:ext cx="19800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Initial PAH Diagnosis Date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012B040A-7EEA-4518-B59B-0517B200CEDD}"/>
              </a:ext>
            </a:extLst>
          </p:cNvPr>
          <p:cNvSpPr/>
          <p:nvPr/>
        </p:nvSpPr>
        <p:spPr>
          <a:xfrm>
            <a:off x="816428" y="2245191"/>
            <a:ext cx="1044000" cy="43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</a:rPr>
              <a:t>SEL ≤12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4EB99CCB-01EC-4DA5-A079-2297BE694DBE}"/>
              </a:ext>
            </a:extLst>
          </p:cNvPr>
          <p:cNvSpPr/>
          <p:nvPr/>
        </p:nvSpPr>
        <p:spPr>
          <a:xfrm>
            <a:off x="816428" y="4330798"/>
            <a:ext cx="1044000" cy="43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</a:rPr>
              <a:t>No PPA ≤12†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69D0EB6-C2F6-8351-55E3-0F492E94F95E}"/>
              </a:ext>
            </a:extLst>
          </p:cNvPr>
          <p:cNvSpPr txBox="1"/>
          <p:nvPr/>
        </p:nvSpPr>
        <p:spPr>
          <a:xfrm>
            <a:off x="131884" y="311705"/>
            <a:ext cx="2544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. Study Timelin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96C3DFB-D540-6FA1-31F4-28E2C6E6A505}"/>
              </a:ext>
            </a:extLst>
          </p:cNvPr>
          <p:cNvSpPr txBox="1"/>
          <p:nvPr/>
        </p:nvSpPr>
        <p:spPr>
          <a:xfrm>
            <a:off x="704675" y="5585897"/>
            <a:ext cx="10175845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300"/>
              </a:spcBef>
              <a:spcAft>
                <a:spcPts val="0"/>
              </a:spcAft>
            </a:pPr>
            <a:r>
              <a:rPr lang="en-US" sz="10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breviations: CTEPH = chronic thromboembolic pulmonary hypertension; PAH = pulmonary arterial hypertension;</a:t>
            </a:r>
            <a:br>
              <a:rPr lang="en-US" sz="10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0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PA = prostacyclin pathway agent</a:t>
            </a:r>
          </a:p>
          <a:p>
            <a:pPr marL="0" marR="0">
              <a:spcBef>
                <a:spcPts val="300"/>
              </a:spcBef>
              <a:spcAft>
                <a:spcPts val="0"/>
              </a:spcAft>
            </a:pPr>
            <a:r>
              <a:rPr lang="en-US" sz="10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†Includes patients who initiated treatment with PAH therapy other than oral/inhaled PPAs (including selexipag).</a:t>
            </a:r>
          </a:p>
          <a:p>
            <a:pPr marL="0" marR="0">
              <a:spcBef>
                <a:spcPts val="300"/>
              </a:spcBef>
              <a:spcAft>
                <a:spcPts val="0"/>
              </a:spcAft>
            </a:pPr>
            <a:r>
              <a:rPr lang="en-US" sz="10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‡Period used to identify newly diagnosed patients with PAH.</a:t>
            </a:r>
          </a:p>
        </p:txBody>
      </p:sp>
    </p:spTree>
    <p:extLst>
      <p:ext uri="{BB962C8B-B14F-4D97-AF65-F5344CB8AC3E}">
        <p14:creationId xmlns:p14="http://schemas.microsoft.com/office/powerpoint/2010/main" val="32455738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843653BC-0BB1-4CAA-8610-3F17E72C8520}"/>
              </a:ext>
            </a:extLst>
          </p:cNvPr>
          <p:cNvGraphicFramePr>
            <a:graphicFrameLocks/>
          </p:cNvGraphicFramePr>
          <p:nvPr/>
        </p:nvGraphicFramePr>
        <p:xfrm>
          <a:off x="1123388" y="1877545"/>
          <a:ext cx="5037045" cy="31029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45FD348-104B-46E1-994E-978A1AD41099}"/>
              </a:ext>
            </a:extLst>
          </p:cNvPr>
          <p:cNvGraphicFramePr>
            <a:graphicFrameLocks/>
          </p:cNvGraphicFramePr>
          <p:nvPr/>
        </p:nvGraphicFramePr>
        <p:xfrm>
          <a:off x="6177243" y="1877544"/>
          <a:ext cx="4891368" cy="31029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F8A66EA-6696-FA55-B0F8-E383E7D6FE5F}"/>
              </a:ext>
            </a:extLst>
          </p:cNvPr>
          <p:cNvSpPr txBox="1"/>
          <p:nvPr/>
        </p:nvSpPr>
        <p:spPr>
          <a:xfrm>
            <a:off x="131884" y="311705"/>
            <a:ext cx="36935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. Main Drivers of Total Cos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3AAA91C-072A-8AC5-3EA5-2D9AB93E5633}"/>
              </a:ext>
            </a:extLst>
          </p:cNvPr>
          <p:cNvSpPr txBox="1"/>
          <p:nvPr/>
        </p:nvSpPr>
        <p:spPr>
          <a:xfrm>
            <a:off x="226503" y="847288"/>
            <a:ext cx="14261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) All-cause</a:t>
            </a:r>
          </a:p>
        </p:txBody>
      </p:sp>
    </p:spTree>
    <p:extLst>
      <p:ext uri="{BB962C8B-B14F-4D97-AF65-F5344CB8AC3E}">
        <p14:creationId xmlns:p14="http://schemas.microsoft.com/office/powerpoint/2010/main" val="24173569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EACE8F0-8B29-4D81-988A-6DA264649408}"/>
              </a:ext>
            </a:extLst>
          </p:cNvPr>
          <p:cNvGraphicFramePr>
            <a:graphicFrameLocks/>
          </p:cNvGraphicFramePr>
          <p:nvPr/>
        </p:nvGraphicFramePr>
        <p:xfrm>
          <a:off x="1218951" y="1905560"/>
          <a:ext cx="4789892" cy="30580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53CFE14-EFD6-4E7B-96C2-ED28F8F9438E}"/>
              </a:ext>
            </a:extLst>
          </p:cNvPr>
          <p:cNvGraphicFramePr>
            <a:graphicFrameLocks/>
          </p:cNvGraphicFramePr>
          <p:nvPr/>
        </p:nvGraphicFramePr>
        <p:xfrm>
          <a:off x="6031254" y="1894354"/>
          <a:ext cx="4941794" cy="30692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CAF2787-AD21-BB4F-CC91-DE4B77DEC4BB}"/>
              </a:ext>
            </a:extLst>
          </p:cNvPr>
          <p:cNvSpPr txBox="1"/>
          <p:nvPr/>
        </p:nvSpPr>
        <p:spPr>
          <a:xfrm>
            <a:off x="131884" y="311705"/>
            <a:ext cx="3559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. Main Drivers of Total Cos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6AB983A-2A6E-EE89-B99B-8B6F75CB4520}"/>
              </a:ext>
            </a:extLst>
          </p:cNvPr>
          <p:cNvSpPr txBox="1"/>
          <p:nvPr/>
        </p:nvSpPr>
        <p:spPr>
          <a:xfrm>
            <a:off x="226503" y="847288"/>
            <a:ext cx="21475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) PAH-related</a:t>
            </a:r>
          </a:p>
        </p:txBody>
      </p:sp>
    </p:spTree>
    <p:extLst>
      <p:ext uri="{BB962C8B-B14F-4D97-AF65-F5344CB8AC3E}">
        <p14:creationId xmlns:p14="http://schemas.microsoft.com/office/powerpoint/2010/main" val="14682774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12BB303D974A947881D64AB9466283D" ma:contentTypeVersion="4" ma:contentTypeDescription="Create a new document." ma:contentTypeScope="" ma:versionID="bd1d7cbd331b8abf423e2c7f5b1040ba">
  <xsd:schema xmlns:xsd="http://www.w3.org/2001/XMLSchema" xmlns:xs="http://www.w3.org/2001/XMLSchema" xmlns:p="http://schemas.microsoft.com/office/2006/metadata/properties" xmlns:ns2="85a8c8f4-8518-4be1-bf2b-d4601bbb97a4" targetNamespace="http://schemas.microsoft.com/office/2006/metadata/properties" ma:root="true" ma:fieldsID="238b882e2dd7c2a6ec29c38c731b635d" ns2:_="">
    <xsd:import namespace="85a8c8f4-8518-4be1-bf2b-d4601bbb97a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5a8c8f4-8518-4be1-bf2b-d4601bbb97a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3B018AF-F674-4DE5-BA00-679FE272AFB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5a8c8f4-8518-4be1-bf2b-d4601bbb97a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7CE2866-3AB3-423F-8637-E0FFC45AC02F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55CD1917-93DA-4F8D-BAC5-94EA1A6EE286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87</Words>
  <Application>Microsoft Office PowerPoint</Application>
  <PresentationFormat>Widescreen</PresentationFormat>
  <Paragraphs>35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iya Udayachalerm</dc:creator>
  <cp:lastModifiedBy>Michael Stokes</cp:lastModifiedBy>
  <cp:revision>8</cp:revision>
  <dcterms:created xsi:type="dcterms:W3CDTF">2023-03-02T14:58:36Z</dcterms:created>
  <dcterms:modified xsi:type="dcterms:W3CDTF">2023-10-03T18:32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12BB303D974A947881D64AB9466283D</vt:lpwstr>
  </property>
</Properties>
</file>